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505F4-F179-4C1A-ABA2-0562C1E7AF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72B31-AE1A-4224-AEF1-0F53D69722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91BF9-4179-4487-AC92-0E6F26326D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57178-928C-48EF-A945-2B2144E1D8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DAD43-4863-42C3-9A04-05D88F6186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1C638-204E-4DDE-89AA-4FC01E1C5E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A6A89-658E-4E6B-A104-073AEDB83C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A426D-3545-4957-A15C-8AE8E8EC6F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DB8B5-9306-42C6-891F-CB4F49F86A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C828E-AA56-4CF3-B7CD-5984900F75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25087-784E-4CCC-85BA-6239668BDC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D7876-7F3E-4B69-9017-AA33DDD3FD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3A05E7-6531-4C9D-9D13-D51D9477C1F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2"/>
          <p:cNvGrpSpPr/>
          <p:nvPr/>
        </p:nvGrpSpPr>
        <p:grpSpPr>
          <a:xfrm>
            <a:off x="2919240" y="2570040"/>
            <a:ext cx="2261880" cy="1014120"/>
            <a:chOff x="2919240" y="2570040"/>
            <a:chExt cx="2261880" cy="1014120"/>
          </a:xfrm>
        </p:grpSpPr>
        <p:sp>
          <p:nvSpPr>
            <p:cNvPr id="42" name="Rectangle 43"/>
            <p:cNvSpPr/>
            <p:nvPr/>
          </p:nvSpPr>
          <p:spPr>
            <a:xfrm>
              <a:off x="2919240" y="2570040"/>
              <a:ext cx="2261880" cy="1014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44"/>
            <p:cNvSpPr/>
            <p:nvPr/>
          </p:nvSpPr>
          <p:spPr>
            <a:xfrm>
              <a:off x="2919240" y="2570040"/>
              <a:ext cx="2261880" cy="101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oup 45"/>
          <p:cNvGrpSpPr/>
          <p:nvPr/>
        </p:nvGrpSpPr>
        <p:grpSpPr>
          <a:xfrm>
            <a:off x="4947120" y="4454640"/>
            <a:ext cx="447840" cy="164880"/>
            <a:chOff x="4947120" y="4454640"/>
            <a:chExt cx="447840" cy="164880"/>
          </a:xfrm>
        </p:grpSpPr>
        <p:sp>
          <p:nvSpPr>
            <p:cNvPr id="45" name="Rectangle 46"/>
            <p:cNvSpPr/>
            <p:nvPr/>
          </p:nvSpPr>
          <p:spPr>
            <a:xfrm>
              <a:off x="4947120" y="446688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88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47"/>
            <p:cNvSpPr/>
            <p:nvPr/>
          </p:nvSpPr>
          <p:spPr>
            <a:xfrm>
              <a:off x="5266080" y="44546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48"/>
          <p:cNvGrpSpPr/>
          <p:nvPr/>
        </p:nvGrpSpPr>
        <p:grpSpPr>
          <a:xfrm>
            <a:off x="4946760" y="3778200"/>
            <a:ext cx="438480" cy="152640"/>
            <a:chOff x="4946760" y="3778200"/>
            <a:chExt cx="438480" cy="152640"/>
          </a:xfrm>
        </p:grpSpPr>
        <p:sp>
          <p:nvSpPr>
            <p:cNvPr id="48" name="Rectangle 49"/>
            <p:cNvSpPr/>
            <p:nvPr/>
          </p:nvSpPr>
          <p:spPr>
            <a:xfrm>
              <a:off x="4946760" y="37782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50"/>
            <p:cNvSpPr/>
            <p:nvPr/>
          </p:nvSpPr>
          <p:spPr>
            <a:xfrm>
              <a:off x="5256360" y="377820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Rectangle 51"/>
          <p:cNvSpPr/>
          <p:nvPr/>
        </p:nvSpPr>
        <p:spPr>
          <a:xfrm rot="18240000">
            <a:off x="2899800" y="3148200"/>
            <a:ext cx="75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HTXSpcdc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2"/>
          <p:cNvSpPr/>
          <p:nvPr/>
        </p:nvSpPr>
        <p:spPr>
          <a:xfrm rot="18240000">
            <a:off x="3664800" y="25984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53"/>
          <p:cNvSpPr/>
          <p:nvPr/>
        </p:nvSpPr>
        <p:spPr>
          <a:xfrm rot="18240000">
            <a:off x="3380760" y="3123360"/>
            <a:ext cx="75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HTXSpcdc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4"/>
          <p:cNvSpPr/>
          <p:nvPr/>
        </p:nvSpPr>
        <p:spPr>
          <a:xfrm rot="18240000">
            <a:off x="4164840" y="2613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55"/>
          <p:cNvSpPr/>
          <p:nvPr/>
        </p:nvSpPr>
        <p:spPr>
          <a:xfrm rot="18240000">
            <a:off x="4044600" y="333360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6"/>
          <p:cNvSpPr/>
          <p:nvPr/>
        </p:nvSpPr>
        <p:spPr>
          <a:xfrm rot="18240000">
            <a:off x="4451040" y="3291840"/>
            <a:ext cx="31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H2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7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8"/>
          <p:cNvSpPr/>
          <p:nvPr/>
        </p:nvSpPr>
        <p:spPr>
          <a:xfrm rot="18240000">
            <a:off x="4707000" y="292320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60"/>
          <p:cNvSpPr/>
          <p:nvPr/>
        </p:nvSpPr>
        <p:spPr>
          <a:xfrm>
            <a:off x="1201680" y="4521240"/>
            <a:ext cx="19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18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61"/>
          <p:cNvSpPr/>
          <p:nvPr/>
        </p:nvSpPr>
        <p:spPr>
          <a:xfrm>
            <a:off x="1498320" y="4521240"/>
            <a:ext cx="1142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Times New Roman"/>
              </a:rPr>
              <a:t>rRNA loading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62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63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65"/>
          <p:cNvSpPr/>
          <p:nvPr/>
        </p:nvSpPr>
        <p:spPr>
          <a:xfrm>
            <a:off x="2919240" y="2570040"/>
            <a:ext cx="2262240" cy="1014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66"/>
          <p:cNvSpPr/>
          <p:nvPr/>
        </p:nvSpPr>
        <p:spPr>
          <a:xfrm>
            <a:off x="2919240" y="2570040"/>
            <a:ext cx="2262240" cy="101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67" descr=""/>
          <p:cNvPicPr/>
          <p:nvPr/>
        </p:nvPicPr>
        <p:blipFill>
          <a:blip r:embed="rId1"/>
          <a:srcRect l="0" t="24089" r="0" b="19308"/>
          <a:stretch/>
        </p:blipFill>
        <p:spPr>
          <a:xfrm>
            <a:off x="2975040" y="4327560"/>
            <a:ext cx="1940040" cy="5698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68" descr=""/>
          <p:cNvPicPr/>
          <p:nvPr/>
        </p:nvPicPr>
        <p:blipFill>
          <a:blip r:embed="rId2"/>
          <a:srcRect l="0" t="17940" r="0" b="19145"/>
          <a:stretch/>
        </p:blipFill>
        <p:spPr>
          <a:xfrm>
            <a:off x="2952720" y="3641760"/>
            <a:ext cx="1970280" cy="63828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69"/>
          <p:cNvSpPr/>
          <p:nvPr/>
        </p:nvSpPr>
        <p:spPr>
          <a:xfrm rot="18240000">
            <a:off x="2808360" y="2993760"/>
            <a:ext cx="1126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TX::Spcdc25 line 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70"/>
          <p:cNvSpPr/>
          <p:nvPr/>
        </p:nvSpPr>
        <p:spPr>
          <a:xfrm rot="18240000">
            <a:off x="3306600" y="2991960"/>
            <a:ext cx="1063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TX::Spcdc25 line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71"/>
          <p:cNvSpPr/>
          <p:nvPr/>
        </p:nvSpPr>
        <p:spPr>
          <a:xfrm rot="18240000">
            <a:off x="4044600" y="333360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72"/>
          <p:cNvSpPr/>
          <p:nvPr/>
        </p:nvSpPr>
        <p:spPr>
          <a:xfrm rot="18240000">
            <a:off x="4451040" y="3291840"/>
            <a:ext cx="31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H2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73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74"/>
          <p:cNvSpPr/>
          <p:nvPr/>
        </p:nvSpPr>
        <p:spPr>
          <a:xfrm rot="18240000">
            <a:off x="4710600" y="292356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75"/>
          <p:cNvSpPr/>
          <p:nvPr/>
        </p:nvSpPr>
        <p:spPr>
          <a:xfrm>
            <a:off x="1603440" y="3816360"/>
            <a:ext cx="896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</a:rPr>
              <a:t>BTX::Spcdc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76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7"/>
          <p:cNvSpPr/>
          <p:nvPr/>
        </p:nvSpPr>
        <p:spPr>
          <a:xfrm rot="18240000">
            <a:off x="4758120" y="3107160"/>
            <a:ext cx="43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8"/>
          <p:cNvSpPr/>
          <p:nvPr/>
        </p:nvSpPr>
        <p:spPr>
          <a:xfrm>
            <a:off x="1531800" y="5256360"/>
            <a:ext cx="3962520" cy="101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xpression levels of </a:t>
            </a: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pcdc25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in transgenic lines of Arabidop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RT-PCR of BTX::Spcdc25 lines 9 and 10 showing expression of the transgene in both lines (lower band is primer dime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80"/>
          <p:cNvSpPr/>
          <p:nvPr/>
        </p:nvSpPr>
        <p:spPr>
          <a:xfrm>
            <a:off x="2004840" y="6861240"/>
            <a:ext cx="28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1 Spadafo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8T17:55:59Z</dcterms:created>
  <dc:creator>INSRV</dc:creator>
  <dc:description/>
  <dc:language>en-US</dc:language>
  <cp:lastModifiedBy>INSRV</cp:lastModifiedBy>
  <dcterms:modified xsi:type="dcterms:W3CDTF">2012-01-26T12:13:52Z</dcterms:modified>
  <cp:revision>1</cp:revision>
  <dc:subject/>
  <dc:title>Slide 1</dc:title>
</cp:coreProperties>
</file>